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138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0A1031-214C-4A24-9A71-DDBEE589D231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B262C7-D2AE-4433-8FD9-18D55B3357CA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07683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B262C7-D2AE-4433-8FD9-18D55B3357CA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5954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55455-7F33-444D-9E04-E8953932F6FF}" type="datetimeFigureOut">
              <a:rPr lang="es-ES" smtClean="0"/>
              <a:t>27/07/20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9B065B-54C5-4A42-9329-6B8D2729BA8F}" type="slidenum">
              <a:rPr lang="es-ES" smtClean="0"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7 Rectángulo"/>
          <p:cNvSpPr/>
          <p:nvPr/>
        </p:nvSpPr>
        <p:spPr>
          <a:xfrm>
            <a:off x="1835696" y="620688"/>
            <a:ext cx="1656184" cy="64807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Intervention group</a:t>
            </a:r>
          </a:p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2,077</a:t>
            </a:r>
            <a:endParaRPr 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10 Rectángulo"/>
          <p:cNvSpPr/>
          <p:nvPr/>
        </p:nvSpPr>
        <p:spPr>
          <a:xfrm>
            <a:off x="3563888" y="2060848"/>
            <a:ext cx="1584176" cy="79208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ggregated subjects of Eira phase I and phase II EIRA study</a:t>
            </a:r>
          </a:p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4,259</a:t>
            </a:r>
            <a:endParaRPr 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" name="24 Conector angular"/>
          <p:cNvCxnSpPr>
            <a:stCxn id="8" idx="2"/>
            <a:endCxn id="11" idx="1"/>
          </p:cNvCxnSpPr>
          <p:nvPr/>
        </p:nvCxnSpPr>
        <p:spPr>
          <a:xfrm rot="16200000" flipH="1">
            <a:off x="2519772" y="1412776"/>
            <a:ext cx="1188132" cy="900100"/>
          </a:xfrm>
          <a:prstGeom prst="bentConnector2">
            <a:avLst/>
          </a:prstGeom>
          <a:ln w="158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28 Forma"/>
          <p:cNvCxnSpPr>
            <a:stCxn id="46" idx="2"/>
            <a:endCxn id="11" idx="3"/>
          </p:cNvCxnSpPr>
          <p:nvPr/>
        </p:nvCxnSpPr>
        <p:spPr>
          <a:xfrm rot="5400000">
            <a:off x="5040052" y="1376772"/>
            <a:ext cx="1188132" cy="972108"/>
          </a:xfrm>
          <a:prstGeom prst="bentConnector2">
            <a:avLst/>
          </a:prstGeom>
          <a:ln w="158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31 Rectángulo"/>
          <p:cNvSpPr/>
          <p:nvPr/>
        </p:nvSpPr>
        <p:spPr>
          <a:xfrm>
            <a:off x="1547664" y="3645024"/>
            <a:ext cx="1728192" cy="792088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ubjects with a cancer diagnosis  (survivors)</a:t>
            </a:r>
          </a:p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190</a:t>
            </a:r>
            <a:endParaRPr 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" name="35 Forma"/>
          <p:cNvCxnSpPr>
            <a:stCxn id="11" idx="2"/>
            <a:endCxn id="63" idx="1"/>
          </p:cNvCxnSpPr>
          <p:nvPr/>
        </p:nvCxnSpPr>
        <p:spPr>
          <a:xfrm rot="16200000" flipH="1">
            <a:off x="4337974" y="2870938"/>
            <a:ext cx="1188132" cy="1152128"/>
          </a:xfrm>
          <a:prstGeom prst="bentConnector2">
            <a:avLst/>
          </a:prstGeom>
          <a:ln w="158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37 Forma"/>
          <p:cNvCxnSpPr>
            <a:stCxn id="11" idx="2"/>
            <a:endCxn id="32" idx="3"/>
          </p:cNvCxnSpPr>
          <p:nvPr/>
        </p:nvCxnSpPr>
        <p:spPr>
          <a:xfrm rot="5400000">
            <a:off x="3221850" y="2906942"/>
            <a:ext cx="1188132" cy="1080120"/>
          </a:xfrm>
          <a:prstGeom prst="bentConnector2">
            <a:avLst/>
          </a:prstGeom>
          <a:ln w="158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40 Rectángulo"/>
          <p:cNvSpPr/>
          <p:nvPr/>
        </p:nvSpPr>
        <p:spPr>
          <a:xfrm>
            <a:off x="1475656" y="5733256"/>
            <a:ext cx="4680520" cy="5760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Figure </a:t>
            </a:r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1</a:t>
            </a:r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.</a:t>
            </a:r>
          </a:p>
          <a:p>
            <a:r>
              <a:rPr lang="en-US" sz="100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Flow </a:t>
            </a:r>
            <a:r>
              <a:rPr lang="en-US" sz="100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</a:t>
            </a:r>
            <a:r>
              <a:rPr lang="en-US" sz="100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art of </a:t>
            </a:r>
            <a:r>
              <a:rPr lang="en-U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ubjects. Phase II and III study EIRA</a:t>
            </a:r>
            <a:r>
              <a:rPr lang="es-ES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.</a:t>
            </a:r>
            <a:endParaRPr lang="es-ES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45 Rectángulo"/>
          <p:cNvSpPr/>
          <p:nvPr/>
        </p:nvSpPr>
        <p:spPr>
          <a:xfrm>
            <a:off x="5292080" y="620688"/>
            <a:ext cx="1656184" cy="64807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ontrol group</a:t>
            </a:r>
          </a:p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2,182</a:t>
            </a:r>
            <a:endParaRPr 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62 Rectángulo"/>
          <p:cNvSpPr/>
          <p:nvPr/>
        </p:nvSpPr>
        <p:spPr>
          <a:xfrm>
            <a:off x="5508104" y="3645024"/>
            <a:ext cx="1728192" cy="792088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ubjects without a cancer diagnosis 4,069</a:t>
            </a:r>
            <a:endParaRPr lang="en-US" sz="12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49</Words>
  <Application>Microsoft Office PowerPoint</Application>
  <PresentationFormat>On-screen Show (4:3)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98740</dc:creator>
  <cp:lastModifiedBy>scm</cp:lastModifiedBy>
  <cp:revision>11</cp:revision>
  <dcterms:created xsi:type="dcterms:W3CDTF">2019-08-30T11:56:12Z</dcterms:created>
  <dcterms:modified xsi:type="dcterms:W3CDTF">2020-07-27T15:18:35Z</dcterms:modified>
</cp:coreProperties>
</file>